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86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6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55" autoAdjust="0"/>
    <p:restoredTop sz="94660"/>
  </p:normalViewPr>
  <p:slideViewPr>
    <p:cSldViewPr snapToGrid="0">
      <p:cViewPr varScale="1">
        <p:scale>
          <a:sx n="88" d="100"/>
          <a:sy n="88" d="100"/>
        </p:scale>
        <p:origin x="894" y="96"/>
      </p:cViewPr>
      <p:guideLst>
        <p:guide orient="horz" pos="236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34C80E0-2F9E-40CB-942F-2F61169E2F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72DA7C40-3D5B-4CB6-98CE-7F1EE3EBB1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02DF0A5-B7C9-44BF-AD87-E72159559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08BA794-758A-43DA-B1EE-F82A9E8EE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408109A-B471-4D29-ABA7-63BC063ED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5624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BA24970-3C7B-411A-8C47-C9AA1FF8C9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20AF732E-C7CA-4F62-A38B-1AF91A7381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E0E006A-716C-46AA-97F1-44CEF342E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89F6321-C413-4072-9455-EA2CF9E18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F526CAA-7E56-4D87-B682-3EA48A500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430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3723BD1D-0928-47E7-822B-A36781DEAF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34B4D69-0F85-40AD-B253-12A11333D6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5A5ECE2-4F98-49B8-B748-DE1ACA794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32DCF4B-FC18-4D72-9E8D-2C11D47CE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88A7F55-AF7D-4B82-B297-9963AA3F0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2590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2E8F083-17C0-451D-B46C-06E1E4A1EF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4A61029-7FCC-4B6F-B886-4E36F2CE8F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36D9B29-1D5B-4AE5-8C5F-EF7D8D786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6D93B73-7429-4D7A-AA1C-D5FED8E72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699A945-B18D-47A0-BC57-4CDA09444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405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DD201FB-01D4-4EC9-99D7-FED88D357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6B16F49-600C-402B-ABC3-6D259A42C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9EC8C4C-459A-4250-802F-CFF05FFBA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D0FB0B0-7179-45B8-B11F-B659C71A8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D085B8B-DC42-4B7F-B398-0EB0AF1B9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140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FCB43B6-DE3E-4653-AFB0-2AD72D28C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7A33AC8-97EB-4AFF-B1FA-A1D7FAC418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687BEA4-B2A1-40A5-A74C-2C5537567A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BA9F0CC-EB35-458E-B5A5-CE70024E1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454AF76-75E7-4746-A0BB-96F2AC978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E93B79D-C54A-46DA-812E-0EC5237F8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5234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01C0E8E-00FD-4045-BBFB-6B1D1E9C39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B15DCE1-15A9-435C-B4D3-AB88BE11F6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B3E665C-4B96-4BA9-A198-C90B5558C4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E623DD54-E2E3-4448-A192-5D394F1E1D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8897BE17-1384-440A-8511-3BCDDA3FC0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2DA411B8-F74D-448E-B84B-A53572712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5502DE89-B8F5-4BF7-9A04-736F96E39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42E80C17-2E00-47F5-9FB7-0EA059CB1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0116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09F28A5-8BCE-4A73-BB6F-5513931CE6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C65237DA-5252-459E-BB84-13E400BFC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0A3059D5-68FD-48DF-9293-1A59754BB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B7CD76E3-FC69-41DA-95F9-301D8845C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9371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5D7EAD05-C4D4-4A4E-AED0-AD6585F8A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9552167D-F341-4E56-8BED-08F228E48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6D2587FB-3878-4217-91D7-CD8C45AE3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75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447F3F2-A497-4954-886E-E50FC3BEC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29C0D2F-C22A-40CE-8209-E924502DC0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1E7BC24-2F91-4537-B636-7F63EC17E6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2F577CD-3E9C-4DF9-9EFA-6A581E8EE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7CD420F-5406-4C2C-B162-A1153460D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824DE2B-8E1F-46A7-8958-0FF2DF555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2639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454290A-B68E-4E9A-8011-C227E8B62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502F7A66-D415-4828-9B36-540AD70FA0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A5A6683-F69A-4B78-A747-97FC2089F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3A702F8-458B-4103-894B-BDA65A044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54FA442-4459-45BC-86D9-7A4B25F9A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184E73A-347F-4638-8F4C-9E6F95AC5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9738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ABB4FD6-ECC7-4FE1-B604-A55058CEF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F012DA4-BF94-48F8-92EE-810FD77B04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54864BE-679A-4617-8808-3CA4E4B17D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E1D4C-F597-4827-88F6-8FF419A1E04D}" type="datetimeFigureOut">
              <a:rPr lang="en-GB" smtClean="0"/>
              <a:t>02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8D42B4A-C2E0-42B7-AB6E-4EB92AAC65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44E8D18-D793-49E4-AF39-2D05C87A65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01654-7CCF-424F-9E79-0C7A6A1B551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4803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5517" y="2066412"/>
            <a:ext cx="7260965" cy="3029975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xmlns="" id="{031E4344-F626-4CE1-9E9C-06FFF2CBD34E}"/>
              </a:ext>
            </a:extLst>
          </p:cNvPr>
          <p:cNvSpPr txBox="1"/>
          <p:nvPr/>
        </p:nvSpPr>
        <p:spPr>
          <a:xfrm>
            <a:off x="688498" y="541914"/>
            <a:ext cx="115035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200" b="1" dirty="0" err="1"/>
              <a:t>Sup</a:t>
            </a:r>
            <a:r>
              <a:rPr lang="es-AR" sz="1200" b="1" dirty="0"/>
              <a:t>. file 1. </a:t>
            </a:r>
            <a:r>
              <a:rPr lang="es-AR" sz="1200" b="1" dirty="0" err="1"/>
              <a:t>Heterodimeric</a:t>
            </a:r>
            <a:r>
              <a:rPr lang="es-AR" sz="1200" b="1" dirty="0"/>
              <a:t> receptor </a:t>
            </a:r>
            <a:r>
              <a:rPr lang="es-AR" sz="1200" b="1" dirty="0" err="1"/>
              <a:t>structure</a:t>
            </a:r>
            <a:r>
              <a:rPr lang="es-AR" sz="1200" b="1" dirty="0"/>
              <a:t> and </a:t>
            </a:r>
            <a:r>
              <a:rPr lang="es-AR" sz="1200" b="1" dirty="0" err="1"/>
              <a:t>the</a:t>
            </a:r>
            <a:r>
              <a:rPr lang="es-AR" sz="1200" b="1" dirty="0"/>
              <a:t> </a:t>
            </a:r>
            <a:r>
              <a:rPr lang="es-AR" sz="1200" b="1" dirty="0" err="1"/>
              <a:t>predicited</a:t>
            </a:r>
            <a:r>
              <a:rPr lang="es-AR" sz="1200" b="1" dirty="0"/>
              <a:t> </a:t>
            </a:r>
            <a:r>
              <a:rPr lang="es-AR" sz="1200" b="1" dirty="0" err="1"/>
              <a:t>interaction</a:t>
            </a:r>
            <a:r>
              <a:rPr lang="es-AR" sz="1200" b="1" dirty="0"/>
              <a:t> </a:t>
            </a:r>
            <a:r>
              <a:rPr lang="es-AR" sz="1200" b="1" dirty="0" err="1"/>
              <a:t>between</a:t>
            </a:r>
            <a:r>
              <a:rPr lang="es-AR" sz="1200" b="1" dirty="0"/>
              <a:t> IFN-</a:t>
            </a:r>
            <a:r>
              <a:rPr lang="el-GR" sz="1200" b="1" dirty="0"/>
              <a:t>λ3 </a:t>
            </a:r>
            <a:r>
              <a:rPr lang="es-AR" sz="1200" b="1" dirty="0"/>
              <a:t>and </a:t>
            </a:r>
            <a:r>
              <a:rPr lang="es-AR" sz="1200" b="1" dirty="0" err="1"/>
              <a:t>the</a:t>
            </a:r>
            <a:r>
              <a:rPr lang="es-AR" sz="1200" b="1" dirty="0"/>
              <a:t> human IFNLR. </a:t>
            </a:r>
            <a:r>
              <a:rPr lang="es-AR" sz="1200" dirty="0" err="1"/>
              <a:t>The</a:t>
            </a:r>
            <a:r>
              <a:rPr lang="es-AR" sz="1200" dirty="0"/>
              <a:t> </a:t>
            </a:r>
            <a:r>
              <a:rPr lang="es-AR" sz="1200" dirty="0" err="1"/>
              <a:t>representative</a:t>
            </a:r>
            <a:r>
              <a:rPr lang="es-AR" sz="1200" dirty="0"/>
              <a:t> </a:t>
            </a:r>
            <a:r>
              <a:rPr lang="es-AR" sz="1200" dirty="0" err="1"/>
              <a:t>interaction</a:t>
            </a:r>
            <a:r>
              <a:rPr lang="es-AR" sz="1200" dirty="0"/>
              <a:t> </a:t>
            </a:r>
            <a:r>
              <a:rPr lang="es-AR" sz="1200" dirty="0" err="1"/>
              <a:t>models</a:t>
            </a:r>
            <a:r>
              <a:rPr lang="es-AR" sz="1200" dirty="0"/>
              <a:t>  </a:t>
            </a:r>
            <a:r>
              <a:rPr lang="es-AR" sz="1200" dirty="0" err="1"/>
              <a:t>with</a:t>
            </a:r>
            <a:r>
              <a:rPr lang="es-AR" sz="1200" dirty="0"/>
              <a:t> </a:t>
            </a:r>
            <a:r>
              <a:rPr lang="es-AR" sz="1200" dirty="0" err="1"/>
              <a:t>the</a:t>
            </a:r>
            <a:r>
              <a:rPr lang="es-AR" sz="1200" dirty="0"/>
              <a:t> </a:t>
            </a:r>
            <a:r>
              <a:rPr lang="es-AR" sz="1200" dirty="0" err="1"/>
              <a:t>heterodimeric</a:t>
            </a:r>
            <a:r>
              <a:rPr lang="es-AR" sz="1200" dirty="0"/>
              <a:t> human IFN-</a:t>
            </a:r>
            <a:r>
              <a:rPr lang="el-GR" sz="1200" dirty="0"/>
              <a:t>λ </a:t>
            </a:r>
            <a:r>
              <a:rPr lang="es-AR" sz="1200" dirty="0"/>
              <a:t>receptor (IFNLR) </a:t>
            </a:r>
            <a:r>
              <a:rPr lang="es-AR" sz="1200" dirty="0" err="1"/>
              <a:t>for</a:t>
            </a:r>
            <a:r>
              <a:rPr lang="es-AR" sz="1200" dirty="0"/>
              <a:t> human IFN-</a:t>
            </a:r>
            <a:r>
              <a:rPr lang="el-GR" sz="1200" dirty="0"/>
              <a:t>λ3 </a:t>
            </a:r>
            <a:r>
              <a:rPr lang="el-GR" sz="1200" b="1" dirty="0"/>
              <a:t>(</a:t>
            </a:r>
            <a:r>
              <a:rPr lang="es-AR" sz="1200" b="1" dirty="0"/>
              <a:t>A)</a:t>
            </a:r>
            <a:r>
              <a:rPr lang="es-AR" sz="1200" dirty="0"/>
              <a:t> and </a:t>
            </a:r>
            <a:r>
              <a:rPr lang="es-AR" sz="1200" dirty="0" err="1"/>
              <a:t>bovine</a:t>
            </a:r>
            <a:r>
              <a:rPr lang="es-AR" sz="1200" dirty="0"/>
              <a:t> IFN-</a:t>
            </a:r>
            <a:r>
              <a:rPr lang="el-GR" sz="1200" dirty="0"/>
              <a:t>λ3 </a:t>
            </a:r>
            <a:r>
              <a:rPr lang="el-GR" sz="1200" b="1" dirty="0"/>
              <a:t>(</a:t>
            </a:r>
            <a:r>
              <a:rPr lang="es-AR" sz="1200" b="1" dirty="0"/>
              <a:t>B)</a:t>
            </a:r>
            <a:r>
              <a:rPr lang="es-AR" sz="1200" dirty="0"/>
              <a:t> are </a:t>
            </a:r>
            <a:r>
              <a:rPr lang="es-AR" sz="1200" dirty="0" err="1"/>
              <a:t>depicted</a:t>
            </a:r>
            <a:r>
              <a:rPr lang="es-AR" sz="1200" dirty="0"/>
              <a:t>. HDOCK and UCSF software </a:t>
            </a:r>
            <a:r>
              <a:rPr lang="es-AR" sz="1200" dirty="0" err="1"/>
              <a:t>were</a:t>
            </a:r>
            <a:r>
              <a:rPr lang="es-AR" sz="1200" dirty="0"/>
              <a:t> </a:t>
            </a:r>
            <a:r>
              <a:rPr lang="es-AR" sz="1200" dirty="0" err="1"/>
              <a:t>used</a:t>
            </a:r>
            <a:r>
              <a:rPr lang="es-AR" sz="1200" dirty="0"/>
              <a:t> </a:t>
            </a:r>
            <a:r>
              <a:rPr lang="es-AR" sz="1200" dirty="0" err="1"/>
              <a:t>for</a:t>
            </a:r>
            <a:r>
              <a:rPr lang="es-AR" sz="1200" dirty="0"/>
              <a:t> </a:t>
            </a:r>
            <a:r>
              <a:rPr lang="es-AR" sz="1200" dirty="0" err="1"/>
              <a:t>docking</a:t>
            </a:r>
            <a:r>
              <a:rPr lang="es-AR" sz="1200" dirty="0"/>
              <a:t> and </a:t>
            </a:r>
            <a:r>
              <a:rPr lang="es-AR" sz="1200" dirty="0" err="1"/>
              <a:t>visualizing</a:t>
            </a:r>
            <a:r>
              <a:rPr lang="es-AR" sz="1200" dirty="0"/>
              <a:t>, </a:t>
            </a:r>
            <a:r>
              <a:rPr lang="es-AR" sz="1200" dirty="0" err="1"/>
              <a:t>respectively</a:t>
            </a:r>
            <a:r>
              <a:rPr lang="es-AR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116597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33</TotalTime>
  <Words>64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o Perez</dc:creator>
  <cp:lastModifiedBy>Nancy Patricia Cardoso</cp:lastModifiedBy>
  <cp:revision>301</cp:revision>
  <cp:lastPrinted>2020-07-31T17:54:55Z</cp:lastPrinted>
  <dcterms:created xsi:type="dcterms:W3CDTF">2020-05-18T17:49:30Z</dcterms:created>
  <dcterms:modified xsi:type="dcterms:W3CDTF">2020-09-02T23:10:22Z</dcterms:modified>
</cp:coreProperties>
</file>